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9.xml.rels" ContentType="application/vnd.openxmlformats-package.relationships+xml"/>
  <Override PartName="/ppt/notesSlides/_rels/notesSlide6.xml.rels" ContentType="application/vnd.openxmlformats-package.relationships+xml"/>
  <Override PartName="/ppt/notesSlides/_rels/notesSlide8.xml.rels" ContentType="application/vnd.openxmlformats-package.relationships+xml"/>
  <Override PartName="/ppt/notesSlides/_rels/notesSlide2.xml.rels" ContentType="application/vnd.openxmlformats-package.relationships+xml"/>
  <Override PartName="/ppt/notesSlides/_rels/notesSlide7.xml.rels" ContentType="application/vnd.openxmlformats-package.relationships+xml"/>
  <Override PartName="/ppt/notesSlides/_rels/notesSlide1.xml.rels" ContentType="application/vnd.openxmlformats-package.relationships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4.jpeg" ContentType="image/jpeg"/>
  <Override PartName="/ppt/media/image12.png" ContentType="image/png"/>
  <Override PartName="/ppt/media/image20.jpeg" ContentType="image/jpeg"/>
  <Override PartName="/ppt/media/image7.png" ContentType="image/png"/>
  <Override PartName="/ppt/media/image22.jpeg" ContentType="image/jpeg"/>
  <Override PartName="/ppt/media/image11.png" ContentType="image/png"/>
  <Override PartName="/ppt/media/image19.jpeg" ContentType="image/jpeg"/>
  <Override PartName="/ppt/media/image6.png" ContentType="image/png"/>
  <Override PartName="/ppt/media/image10.png" ContentType="image/png"/>
  <Override PartName="/ppt/media/image5.png" ContentType="image/png"/>
  <Override PartName="/ppt/media/image24.jpeg" ContentType="image/jpeg"/>
  <Override PartName="/ppt/media/image23.jpeg" ContentType="image/jpeg"/>
  <Override PartName="/ppt/media/image18.jpeg" ContentType="image/jpeg"/>
  <Override PartName="/ppt/media/image21.jpeg" ContentType="image/jpeg"/>
  <Override PartName="/ppt/media/image16.jpeg" ContentType="image/jpeg"/>
  <Override PartName="/ppt/media/image15.jpeg" ContentType="image/jpeg"/>
  <Override PartName="/ppt/media/image1.png" ContentType="image/png"/>
  <Override PartName="/ppt/media/image25.jpeg" ContentType="image/jpeg"/>
  <Override PartName="/ppt/media/image2.png" ContentType="image/png"/>
  <Override PartName="/ppt/media/image3.png" ContentType="image/png"/>
  <Override PartName="/ppt/media/image26.png" ContentType="image/png"/>
  <Override PartName="/ppt/media/image17.jpeg" ContentType="image/jpeg"/>
  <Override PartName="/ppt/media/image4.png" ContentType="image/png"/>
  <Override PartName="/ppt/media/image2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</p:sldIdLst>
  <p:sldSz cx="6264275" cy="8110538"/>
  <p:notesSz cx="6807200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07600" cy="9939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4948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55600" y="0"/>
            <a:ext cx="294948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  <a:defRPr b="0" lang="ko-KR" sz="1200" spc="-1" strike="noStrike">
                <a:solidFill>
                  <a:srgbClr val="000000"/>
                </a:solidFill>
                <a:latin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964880" y="745920"/>
            <a:ext cx="2876760" cy="37256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맑은 고딕"/>
              </a:rPr>
              <a:t>Click to move the slide</a:t>
            </a:r>
            <a:endParaRPr b="0" lang="en-US" sz="3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0760" y="4721400"/>
            <a:ext cx="5445000" cy="4471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374"/>
              </a:spcBef>
              <a:buNone/>
              <a:tabLst>
                <a:tab algn="l" pos="0"/>
                <a:tab algn="l" pos="736560"/>
                <a:tab algn="l" pos="1473120"/>
                <a:tab algn="l" pos="2209680"/>
                <a:tab algn="l" pos="2946240"/>
                <a:tab algn="l" pos="3683160"/>
                <a:tab algn="l" pos="4419720"/>
                <a:tab algn="l" pos="5156280"/>
                <a:tab algn="l" pos="5892840"/>
                <a:tab algn="l" pos="6629400"/>
                <a:tab algn="l" pos="7365960"/>
                <a:tab algn="l" pos="8102520"/>
                <a:tab algn="l" pos="8839080"/>
                <a:tab algn="l" pos="9575640"/>
                <a:tab algn="l" pos="103125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맑은 고딕"/>
              </a:rPr>
              <a:t>Click to edit the notes format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441000"/>
            <a:ext cx="294948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55600" y="9441000"/>
            <a:ext cx="294948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  <a:defRPr b="0" lang="ko-KR" sz="1200" spc="-1" strike="noStrike">
                <a:solidFill>
                  <a:srgbClr val="000000"/>
                </a:solidFill>
                <a:latin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fld id="{8FF91DF1-4828-42BB-9F3C-EFEE8383664B}" type="slidenum"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PlaceHolder 1"/>
          <p:cNvSpPr>
            <a:spLocks noGrp="1"/>
          </p:cNvSpPr>
          <p:nvPr>
            <p:ph type="sldImg"/>
          </p:nvPr>
        </p:nvSpPr>
        <p:spPr>
          <a:xfrm>
            <a:off x="1965240" y="746280"/>
            <a:ext cx="2876760" cy="3725640"/>
          </a:xfrm>
          <a:prstGeom prst="rect">
            <a:avLst/>
          </a:prstGeom>
          <a:ln w="0">
            <a:noFill/>
          </a:ln>
        </p:spPr>
      </p:sp>
      <p:sp>
        <p:nvSpPr>
          <p:cNvPr id="151" name="PlaceHolder 2"/>
          <p:cNvSpPr>
            <a:spLocks noGrp="1"/>
          </p:cNvSpPr>
          <p:nvPr>
            <p:ph type="body"/>
          </p:nvPr>
        </p:nvSpPr>
        <p:spPr>
          <a:xfrm>
            <a:off x="680760" y="4721400"/>
            <a:ext cx="5445000" cy="4471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374"/>
              </a:spcBef>
              <a:buNone/>
              <a:tabLst>
                <a:tab algn="l" pos="0"/>
                <a:tab algn="l" pos="736560"/>
                <a:tab algn="l" pos="1473120"/>
                <a:tab algn="l" pos="2209680"/>
                <a:tab algn="l" pos="2946240"/>
                <a:tab algn="l" pos="3683160"/>
                <a:tab algn="l" pos="4419720"/>
                <a:tab algn="l" pos="5156280"/>
                <a:tab algn="l" pos="5892840"/>
                <a:tab algn="l" pos="6629400"/>
                <a:tab algn="l" pos="7365960"/>
                <a:tab algn="l" pos="8102520"/>
                <a:tab algn="l" pos="8839080"/>
                <a:tab algn="l" pos="9575640"/>
                <a:tab algn="l" pos="10312560"/>
              </a:tabLst>
            </a:pPr>
            <a:endParaRPr b="0" lang="ko-KR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2" name="슬라이드 번호 개체 틀 3"/>
          <p:cNvSpPr/>
          <p:nvPr/>
        </p:nvSpPr>
        <p:spPr>
          <a:xfrm>
            <a:off x="3855960" y="9441000"/>
            <a:ext cx="294948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fld id="{FF8226D7-2377-422F-AB31-8FC0A32EDB36}" type="slidenum"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PlaceHolder 1"/>
          <p:cNvSpPr>
            <a:spLocks noGrp="1"/>
          </p:cNvSpPr>
          <p:nvPr>
            <p:ph type="sldImg"/>
          </p:nvPr>
        </p:nvSpPr>
        <p:spPr>
          <a:xfrm>
            <a:off x="1965240" y="746280"/>
            <a:ext cx="2876760" cy="3725640"/>
          </a:xfrm>
          <a:prstGeom prst="rect">
            <a:avLst/>
          </a:prstGeom>
          <a:ln w="0">
            <a:noFill/>
          </a:ln>
        </p:spPr>
      </p:sp>
      <p:sp>
        <p:nvSpPr>
          <p:cNvPr id="154" name="PlaceHolder 2"/>
          <p:cNvSpPr>
            <a:spLocks noGrp="1"/>
          </p:cNvSpPr>
          <p:nvPr>
            <p:ph type="body"/>
          </p:nvPr>
        </p:nvSpPr>
        <p:spPr>
          <a:xfrm>
            <a:off x="680760" y="4721400"/>
            <a:ext cx="5445000" cy="4471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374"/>
              </a:spcBef>
              <a:buNone/>
              <a:tabLst>
                <a:tab algn="l" pos="0"/>
                <a:tab algn="l" pos="736560"/>
                <a:tab algn="l" pos="1473120"/>
                <a:tab algn="l" pos="2209680"/>
                <a:tab algn="l" pos="2946240"/>
                <a:tab algn="l" pos="3683160"/>
                <a:tab algn="l" pos="4419720"/>
                <a:tab algn="l" pos="5156280"/>
                <a:tab algn="l" pos="5892840"/>
                <a:tab algn="l" pos="6629400"/>
                <a:tab algn="l" pos="7365960"/>
                <a:tab algn="l" pos="8102520"/>
                <a:tab algn="l" pos="8839080"/>
                <a:tab algn="l" pos="9575640"/>
                <a:tab algn="l" pos="10312560"/>
              </a:tabLst>
            </a:pPr>
            <a:endParaRPr b="0" lang="ko-KR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5" name="슬라이드 번호 개체 틀 3"/>
          <p:cNvSpPr/>
          <p:nvPr/>
        </p:nvSpPr>
        <p:spPr>
          <a:xfrm>
            <a:off x="3855960" y="9441000"/>
            <a:ext cx="294948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fld id="{A84B86A1-95B3-4437-B652-226B5CEC498A}" type="slidenum"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PlaceHolder 1"/>
          <p:cNvSpPr>
            <a:spLocks noGrp="1"/>
          </p:cNvSpPr>
          <p:nvPr>
            <p:ph type="sldImg"/>
          </p:nvPr>
        </p:nvSpPr>
        <p:spPr>
          <a:xfrm>
            <a:off x="1965240" y="746280"/>
            <a:ext cx="2876760" cy="3725640"/>
          </a:xfrm>
          <a:prstGeom prst="rect">
            <a:avLst/>
          </a:prstGeom>
          <a:ln w="0">
            <a:noFill/>
          </a:ln>
        </p:spPr>
      </p:sp>
      <p:sp>
        <p:nvSpPr>
          <p:cNvPr id="157" name="PlaceHolder 2"/>
          <p:cNvSpPr>
            <a:spLocks noGrp="1"/>
          </p:cNvSpPr>
          <p:nvPr>
            <p:ph type="body"/>
          </p:nvPr>
        </p:nvSpPr>
        <p:spPr>
          <a:xfrm>
            <a:off x="680760" y="4721400"/>
            <a:ext cx="5445000" cy="4471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374"/>
              </a:spcBef>
              <a:buNone/>
              <a:tabLst>
                <a:tab algn="l" pos="0"/>
                <a:tab algn="l" pos="736560"/>
                <a:tab algn="l" pos="1473120"/>
                <a:tab algn="l" pos="2209680"/>
                <a:tab algn="l" pos="2946240"/>
                <a:tab algn="l" pos="3683160"/>
                <a:tab algn="l" pos="4419720"/>
                <a:tab algn="l" pos="5156280"/>
                <a:tab algn="l" pos="5892840"/>
                <a:tab algn="l" pos="6629400"/>
                <a:tab algn="l" pos="7365960"/>
                <a:tab algn="l" pos="8102520"/>
                <a:tab algn="l" pos="8839080"/>
                <a:tab algn="l" pos="9575640"/>
                <a:tab algn="l" pos="10312560"/>
              </a:tabLst>
            </a:pPr>
            <a:endParaRPr b="0" lang="ko-KR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8" name="슬라이드 번호 개체 틀 3"/>
          <p:cNvSpPr/>
          <p:nvPr/>
        </p:nvSpPr>
        <p:spPr>
          <a:xfrm>
            <a:off x="3855960" y="9441000"/>
            <a:ext cx="294948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fld id="{00169345-3F8C-416D-A4A7-7D85960BDBB9}" type="slidenum"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PlaceHolder 1"/>
          <p:cNvSpPr>
            <a:spLocks noGrp="1"/>
          </p:cNvSpPr>
          <p:nvPr>
            <p:ph type="sldImg"/>
          </p:nvPr>
        </p:nvSpPr>
        <p:spPr>
          <a:xfrm>
            <a:off x="1965240" y="746280"/>
            <a:ext cx="2876760" cy="3725640"/>
          </a:xfrm>
          <a:prstGeom prst="rect">
            <a:avLst/>
          </a:prstGeom>
          <a:ln w="0">
            <a:noFill/>
          </a:ln>
        </p:spPr>
      </p:sp>
      <p:sp>
        <p:nvSpPr>
          <p:cNvPr id="160" name="PlaceHolder 2"/>
          <p:cNvSpPr>
            <a:spLocks noGrp="1"/>
          </p:cNvSpPr>
          <p:nvPr>
            <p:ph type="body"/>
          </p:nvPr>
        </p:nvSpPr>
        <p:spPr>
          <a:xfrm>
            <a:off x="680760" y="4721400"/>
            <a:ext cx="5445000" cy="4471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374"/>
              </a:spcBef>
              <a:buNone/>
              <a:tabLst>
                <a:tab algn="l" pos="0"/>
                <a:tab algn="l" pos="736560"/>
                <a:tab algn="l" pos="1473120"/>
                <a:tab algn="l" pos="2209680"/>
                <a:tab algn="l" pos="2946240"/>
                <a:tab algn="l" pos="3683160"/>
                <a:tab algn="l" pos="4419720"/>
                <a:tab algn="l" pos="5156280"/>
                <a:tab algn="l" pos="5892840"/>
                <a:tab algn="l" pos="6629400"/>
                <a:tab algn="l" pos="7365960"/>
                <a:tab algn="l" pos="8102520"/>
                <a:tab algn="l" pos="8839080"/>
                <a:tab algn="l" pos="9575640"/>
                <a:tab algn="l" pos="10312560"/>
              </a:tabLst>
            </a:pPr>
            <a:endParaRPr b="0" lang="ko-KR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1" name="슬라이드 번호 개체 틀 3"/>
          <p:cNvSpPr/>
          <p:nvPr/>
        </p:nvSpPr>
        <p:spPr>
          <a:xfrm>
            <a:off x="3855960" y="9441000"/>
            <a:ext cx="294948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fld id="{111F1277-0EFE-4A3F-8D68-EE084524DCBB}" type="slidenum"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PlaceHolder 1"/>
          <p:cNvSpPr>
            <a:spLocks noGrp="1"/>
          </p:cNvSpPr>
          <p:nvPr>
            <p:ph type="sldImg"/>
          </p:nvPr>
        </p:nvSpPr>
        <p:spPr>
          <a:xfrm>
            <a:off x="1965240" y="746280"/>
            <a:ext cx="2876760" cy="3725640"/>
          </a:xfrm>
          <a:prstGeom prst="rect">
            <a:avLst/>
          </a:prstGeom>
          <a:ln w="0">
            <a:noFill/>
          </a:ln>
        </p:spPr>
      </p:sp>
      <p:sp>
        <p:nvSpPr>
          <p:cNvPr id="163" name="PlaceHolder 2"/>
          <p:cNvSpPr>
            <a:spLocks noGrp="1"/>
          </p:cNvSpPr>
          <p:nvPr>
            <p:ph type="body"/>
          </p:nvPr>
        </p:nvSpPr>
        <p:spPr>
          <a:xfrm>
            <a:off x="680760" y="4721400"/>
            <a:ext cx="5445000" cy="4471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374"/>
              </a:spcBef>
              <a:buNone/>
              <a:tabLst>
                <a:tab algn="l" pos="0"/>
                <a:tab algn="l" pos="736560"/>
                <a:tab algn="l" pos="1473120"/>
                <a:tab algn="l" pos="2209680"/>
                <a:tab algn="l" pos="2946240"/>
                <a:tab algn="l" pos="3683160"/>
                <a:tab algn="l" pos="4419720"/>
                <a:tab algn="l" pos="5156280"/>
                <a:tab algn="l" pos="5892840"/>
                <a:tab algn="l" pos="6629400"/>
                <a:tab algn="l" pos="7365960"/>
                <a:tab algn="l" pos="8102520"/>
                <a:tab algn="l" pos="8839080"/>
                <a:tab algn="l" pos="9575640"/>
                <a:tab algn="l" pos="10312560"/>
              </a:tabLst>
            </a:pPr>
            <a:endParaRPr b="0" lang="ko-KR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4" name="슬라이드 번호 개체 틀 3"/>
          <p:cNvSpPr/>
          <p:nvPr/>
        </p:nvSpPr>
        <p:spPr>
          <a:xfrm>
            <a:off x="3855960" y="9441000"/>
            <a:ext cx="294948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fld id="{E20BA7F0-3D30-45BC-9168-8A5DBA946667}" type="slidenum"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5" name="PlaceHolder 1"/>
          <p:cNvSpPr>
            <a:spLocks noGrp="1"/>
          </p:cNvSpPr>
          <p:nvPr>
            <p:ph type="sldImg"/>
          </p:nvPr>
        </p:nvSpPr>
        <p:spPr>
          <a:xfrm>
            <a:off x="1965240" y="746280"/>
            <a:ext cx="2876760" cy="3725640"/>
          </a:xfrm>
          <a:prstGeom prst="rect">
            <a:avLst/>
          </a:prstGeom>
          <a:ln w="0">
            <a:noFill/>
          </a:ln>
        </p:spPr>
      </p:sp>
      <p:sp>
        <p:nvSpPr>
          <p:cNvPr id="166" name="PlaceHolder 2"/>
          <p:cNvSpPr>
            <a:spLocks noGrp="1"/>
          </p:cNvSpPr>
          <p:nvPr>
            <p:ph type="body"/>
          </p:nvPr>
        </p:nvSpPr>
        <p:spPr>
          <a:xfrm>
            <a:off x="680760" y="4721400"/>
            <a:ext cx="5445000" cy="4471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374"/>
              </a:spcBef>
              <a:buNone/>
              <a:tabLst>
                <a:tab algn="l" pos="0"/>
                <a:tab algn="l" pos="736560"/>
                <a:tab algn="l" pos="1473120"/>
                <a:tab algn="l" pos="2209680"/>
                <a:tab algn="l" pos="2946240"/>
                <a:tab algn="l" pos="3683160"/>
                <a:tab algn="l" pos="4419720"/>
                <a:tab algn="l" pos="5156280"/>
                <a:tab algn="l" pos="5892840"/>
                <a:tab algn="l" pos="6629400"/>
                <a:tab algn="l" pos="7365960"/>
                <a:tab algn="l" pos="8102520"/>
                <a:tab algn="l" pos="8839080"/>
                <a:tab algn="l" pos="9575640"/>
                <a:tab algn="l" pos="10312560"/>
              </a:tabLst>
            </a:pPr>
            <a:endParaRPr b="0" lang="ko-KR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7" name="슬라이드 번호 개체 틀 3"/>
          <p:cNvSpPr/>
          <p:nvPr/>
        </p:nvSpPr>
        <p:spPr>
          <a:xfrm>
            <a:off x="3855960" y="9441000"/>
            <a:ext cx="294948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fld id="{DCBB7CBC-8273-4214-A66A-C0BFE9205DFA}" type="slidenum"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PlaceHolder 1"/>
          <p:cNvSpPr>
            <a:spLocks noGrp="1"/>
          </p:cNvSpPr>
          <p:nvPr>
            <p:ph type="sldImg"/>
          </p:nvPr>
        </p:nvSpPr>
        <p:spPr>
          <a:xfrm>
            <a:off x="1965240" y="746280"/>
            <a:ext cx="2876760" cy="3725640"/>
          </a:xfrm>
          <a:prstGeom prst="rect">
            <a:avLst/>
          </a:prstGeom>
          <a:ln w="0">
            <a:noFill/>
          </a:ln>
        </p:spPr>
      </p:sp>
      <p:sp>
        <p:nvSpPr>
          <p:cNvPr id="169" name="PlaceHolder 2"/>
          <p:cNvSpPr>
            <a:spLocks noGrp="1"/>
          </p:cNvSpPr>
          <p:nvPr>
            <p:ph type="body"/>
          </p:nvPr>
        </p:nvSpPr>
        <p:spPr>
          <a:xfrm>
            <a:off x="680760" y="4721400"/>
            <a:ext cx="5445000" cy="4471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374"/>
              </a:spcBef>
              <a:buNone/>
              <a:tabLst>
                <a:tab algn="l" pos="0"/>
                <a:tab algn="l" pos="736560"/>
                <a:tab algn="l" pos="1473120"/>
                <a:tab algn="l" pos="2209680"/>
                <a:tab algn="l" pos="2946240"/>
                <a:tab algn="l" pos="3683160"/>
                <a:tab algn="l" pos="4419720"/>
                <a:tab algn="l" pos="5156280"/>
                <a:tab algn="l" pos="5892840"/>
                <a:tab algn="l" pos="6629400"/>
                <a:tab algn="l" pos="7365960"/>
                <a:tab algn="l" pos="8102520"/>
                <a:tab algn="l" pos="8839080"/>
                <a:tab algn="l" pos="9575640"/>
                <a:tab algn="l" pos="10312560"/>
              </a:tabLst>
            </a:pPr>
            <a:endParaRPr b="0" lang="ko-KR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0" name="슬라이드 번호 개체 틀 3"/>
          <p:cNvSpPr/>
          <p:nvPr/>
        </p:nvSpPr>
        <p:spPr>
          <a:xfrm>
            <a:off x="3855960" y="9441000"/>
            <a:ext cx="294948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fld id="{CCED7657-FD71-4646-A81E-E54539B95595}" type="slidenum"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sldImg"/>
          </p:nvPr>
        </p:nvSpPr>
        <p:spPr>
          <a:xfrm>
            <a:off x="1965240" y="746280"/>
            <a:ext cx="2876760" cy="3725640"/>
          </a:xfrm>
          <a:prstGeom prst="rect">
            <a:avLst/>
          </a:prstGeom>
          <a:ln w="0">
            <a:noFill/>
          </a:ln>
        </p:spPr>
      </p:sp>
      <p:sp>
        <p:nvSpPr>
          <p:cNvPr id="172" name="PlaceHolder 2"/>
          <p:cNvSpPr>
            <a:spLocks noGrp="1"/>
          </p:cNvSpPr>
          <p:nvPr>
            <p:ph type="body"/>
          </p:nvPr>
        </p:nvSpPr>
        <p:spPr>
          <a:xfrm>
            <a:off x="680760" y="4721400"/>
            <a:ext cx="5445000" cy="4471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374"/>
              </a:spcBef>
              <a:buNone/>
              <a:tabLst>
                <a:tab algn="l" pos="0"/>
                <a:tab algn="l" pos="736560"/>
                <a:tab algn="l" pos="1473120"/>
                <a:tab algn="l" pos="2209680"/>
                <a:tab algn="l" pos="2946240"/>
                <a:tab algn="l" pos="3683160"/>
                <a:tab algn="l" pos="4419720"/>
                <a:tab algn="l" pos="5156280"/>
                <a:tab algn="l" pos="5892840"/>
                <a:tab algn="l" pos="6629400"/>
                <a:tab algn="l" pos="7365960"/>
                <a:tab algn="l" pos="8102520"/>
                <a:tab algn="l" pos="8839080"/>
                <a:tab algn="l" pos="9575640"/>
                <a:tab algn="l" pos="10312560"/>
              </a:tabLst>
            </a:pPr>
            <a:endParaRPr b="0" lang="ko-KR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3" name="슬라이드 번호 개체 틀 3"/>
          <p:cNvSpPr/>
          <p:nvPr/>
        </p:nvSpPr>
        <p:spPr>
          <a:xfrm>
            <a:off x="3855960" y="9441000"/>
            <a:ext cx="294948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fld id="{68F48914-A58A-4A68-A0A2-53EBEB3CCD6A}" type="slidenum"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</p:note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PlaceHolder 1"/>
          <p:cNvSpPr>
            <a:spLocks noGrp="1"/>
          </p:cNvSpPr>
          <p:nvPr>
            <p:ph type="sldImg"/>
          </p:nvPr>
        </p:nvSpPr>
        <p:spPr>
          <a:xfrm>
            <a:off x="1965240" y="746280"/>
            <a:ext cx="2876760" cy="3725640"/>
          </a:xfrm>
          <a:prstGeom prst="rect">
            <a:avLst/>
          </a:prstGeom>
          <a:ln w="0">
            <a:noFill/>
          </a:ln>
        </p:spPr>
      </p:sp>
      <p:sp>
        <p:nvSpPr>
          <p:cNvPr id="175" name="PlaceHolder 2"/>
          <p:cNvSpPr>
            <a:spLocks noGrp="1"/>
          </p:cNvSpPr>
          <p:nvPr>
            <p:ph type="body"/>
          </p:nvPr>
        </p:nvSpPr>
        <p:spPr>
          <a:xfrm>
            <a:off x="680760" y="4721400"/>
            <a:ext cx="5445000" cy="4471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374"/>
              </a:spcBef>
              <a:buNone/>
              <a:tabLst>
                <a:tab algn="l" pos="0"/>
                <a:tab algn="l" pos="736560"/>
                <a:tab algn="l" pos="1473120"/>
                <a:tab algn="l" pos="2209680"/>
                <a:tab algn="l" pos="2946240"/>
                <a:tab algn="l" pos="3683160"/>
                <a:tab algn="l" pos="4419720"/>
                <a:tab algn="l" pos="5156280"/>
                <a:tab algn="l" pos="5892840"/>
                <a:tab algn="l" pos="6629400"/>
                <a:tab algn="l" pos="7365960"/>
                <a:tab algn="l" pos="8102520"/>
                <a:tab algn="l" pos="8839080"/>
                <a:tab algn="l" pos="9575640"/>
                <a:tab algn="l" pos="10312560"/>
              </a:tabLst>
            </a:pPr>
            <a:endParaRPr b="0" lang="ko-KR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6" name="슬라이드 번호 개체 틀 3"/>
          <p:cNvSpPr/>
          <p:nvPr/>
        </p:nvSpPr>
        <p:spPr>
          <a:xfrm>
            <a:off x="3855960" y="9441000"/>
            <a:ext cx="294948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fld id="{A36C84B1-AF71-4EDD-994F-D09C53459141}" type="slidenum"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DA15A4-1E29-4159-83AE-B91B2A2A9A4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12480" y="325080"/>
            <a:ext cx="5638680" cy="135108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3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12480" y="1892160"/>
            <a:ext cx="5638680" cy="2552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12480" y="4687920"/>
            <a:ext cx="5638680" cy="2552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60E3E7-4397-4628-A62E-F5C4C8F563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12480" y="325080"/>
            <a:ext cx="5638680" cy="135108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3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12480" y="1892160"/>
            <a:ext cx="2751480" cy="2552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201840" y="1892160"/>
            <a:ext cx="2751480" cy="2552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12480" y="4687920"/>
            <a:ext cx="2751480" cy="2552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201840" y="4687920"/>
            <a:ext cx="2751480" cy="2552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82F4CB-C778-42C9-ADCE-587FF3A488F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12480" y="325080"/>
            <a:ext cx="5638680" cy="135108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3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12480" y="1892160"/>
            <a:ext cx="1815480" cy="2552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19040" y="1892160"/>
            <a:ext cx="1815480" cy="2552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125600" y="1892160"/>
            <a:ext cx="1815480" cy="2552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12480" y="4687920"/>
            <a:ext cx="1815480" cy="2552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19040" y="4687920"/>
            <a:ext cx="1815480" cy="2552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125600" y="4687920"/>
            <a:ext cx="1815480" cy="2552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0419B6-7379-4AE9-A30A-5CF043BA969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12480" y="325080"/>
            <a:ext cx="5638680" cy="135108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3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12480" y="1892160"/>
            <a:ext cx="5638680" cy="5351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621F41-9E06-4611-A926-88FA4A4790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12480" y="325080"/>
            <a:ext cx="5638680" cy="135108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3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12480" y="1892160"/>
            <a:ext cx="5638680" cy="5351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5D792F-A6A7-4922-894C-66AC5AE95E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12480" y="325080"/>
            <a:ext cx="5638680" cy="135108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3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12480" y="1892160"/>
            <a:ext cx="2751480" cy="5351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201840" y="1892160"/>
            <a:ext cx="2751480" cy="5351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8AE572-F654-424E-BD0E-76365C3326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12480" y="325080"/>
            <a:ext cx="5638680" cy="135108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3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B6A0F0-94F9-4B60-9640-C43B6D30A9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12480" y="325080"/>
            <a:ext cx="5638680" cy="6264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24"/>
              </a:spcBef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B23F6D-1C36-45DF-B540-8992F8D383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12480" y="325080"/>
            <a:ext cx="5638680" cy="135108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3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12480" y="1892160"/>
            <a:ext cx="2751480" cy="2552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201840" y="1892160"/>
            <a:ext cx="2751480" cy="5351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12480" y="4687920"/>
            <a:ext cx="2751480" cy="2552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F4B58C-5DDA-45BB-8B66-540B394E0A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12480" y="325080"/>
            <a:ext cx="5638680" cy="135108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3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12480" y="1892160"/>
            <a:ext cx="2751480" cy="5351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201840" y="1892160"/>
            <a:ext cx="2751480" cy="2552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201840" y="4687920"/>
            <a:ext cx="2751480" cy="2552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EFB4EA-1462-4524-B7E0-55C2E30C7C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12480" y="325080"/>
            <a:ext cx="5638680" cy="135108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3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12480" y="1892160"/>
            <a:ext cx="2751480" cy="2552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201840" y="1892160"/>
            <a:ext cx="2751480" cy="2552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12480" y="4687920"/>
            <a:ext cx="5638680" cy="2552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080ED3-955B-4F30-89CA-CE52029E4B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12480" y="325080"/>
            <a:ext cx="5638680" cy="135108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ctr">
            <a:noAutofit/>
          </a:bodyPr>
          <a:p>
            <a:pPr indent="0" algn="ct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3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12480" y="1892160"/>
            <a:ext cx="5638680" cy="535176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t">
            <a:normAutofit/>
          </a:bodyPr>
          <a:p>
            <a:pPr marL="268200" indent="-26820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  <a:p>
            <a:pPr lvl="1" marL="584280" indent="-22392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  <a:p>
            <a:pPr lvl="2" marL="898560" indent="-1792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  <a:p>
            <a:pPr lvl="3" marL="1258920" indent="-17928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  <a:p>
            <a:pPr lvl="4" marL="1617840" indent="-17964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  <a:p>
            <a:pPr lvl="5" marL="1617840" indent="-17964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  <a:p>
            <a:pPr lvl="6" marL="1617840" indent="-17964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25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12480" y="7515000"/>
            <a:ext cx="1461960" cy="43164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ctr">
            <a:noAutofit/>
          </a:bodyPr>
          <a:lstStyle>
            <a:lvl1pPr indent="0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  <a:defRPr b="0" lang="ko-KR" sz="1000" spc="-1" strike="noStrike">
                <a:solidFill>
                  <a:srgbClr val="898989"/>
                </a:solidFill>
                <a:latin typeface="맑은 고딕"/>
              </a:defRPr>
            </a:lvl1pPr>
          </a:lstStyle>
          <a:p>
            <a:pPr indent="0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ko-KR" sz="1000" spc="-1" strike="noStrike">
                <a:solidFill>
                  <a:srgbClr val="898989"/>
                </a:solidFill>
                <a:latin typeface="맑은 고딕"/>
              </a:rPr>
              <a:t>&lt;date/time&gt;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39840" y="7515000"/>
            <a:ext cx="1984320" cy="43164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ctr">
            <a:noAutofit/>
          </a:bodyPr>
          <a:p>
            <a:pPr indent="0">
              <a:buNone/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489200" y="7515000"/>
            <a:ext cx="1461960" cy="431640"/>
          </a:xfrm>
          <a:prstGeom prst="rect">
            <a:avLst/>
          </a:prstGeom>
          <a:noFill/>
          <a:ln w="0">
            <a:noFill/>
          </a:ln>
        </p:spPr>
        <p:txBody>
          <a:bodyPr lIns="72000" rIns="72000" tIns="36000" bIns="36000" anchor="ctr">
            <a:noAutofit/>
          </a:bodyPr>
          <a:lstStyle>
            <a:lvl1pPr indent="0" algn="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  <a:defRPr b="0" lang="ko-KR" sz="1000" spc="-1" strike="noStrike">
                <a:solidFill>
                  <a:srgbClr val="898989"/>
                </a:solidFill>
                <a:latin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fld id="{4650325B-A5D0-44B2-AE4B-415E4D0103D7}" type="slidenum">
              <a:rPr b="0" lang="ko-KR" sz="1000" spc="-1" strike="noStrike">
                <a:solidFill>
                  <a:srgbClr val="898989"/>
                </a:solidFill>
                <a:latin typeface="맑은 고딕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image" Target="../media/image9.png"/><Relationship Id="rId6" Type="http://schemas.openxmlformats.org/officeDocument/2006/relationships/image" Target="../media/image10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jpeg"/><Relationship Id="rId3" Type="http://schemas.openxmlformats.org/officeDocument/2006/relationships/image" Target="../media/image15.jpeg"/><Relationship Id="rId4" Type="http://schemas.openxmlformats.org/officeDocument/2006/relationships/image" Target="../media/image16.jpeg"/><Relationship Id="rId5" Type="http://schemas.openxmlformats.org/officeDocument/2006/relationships/image" Target="../media/image17.jpeg"/><Relationship Id="rId6" Type="http://schemas.openxmlformats.org/officeDocument/2006/relationships/image" Target="../media/image18.jpeg"/><Relationship Id="rId7" Type="http://schemas.openxmlformats.org/officeDocument/2006/relationships/image" Target="../media/image19.jpeg"/><Relationship Id="rId8" Type="http://schemas.openxmlformats.org/officeDocument/2006/relationships/image" Target="../media/image20.jpeg"/><Relationship Id="rId9" Type="http://schemas.openxmlformats.org/officeDocument/2006/relationships/image" Target="../media/image21.jpeg"/><Relationship Id="rId10" Type="http://schemas.openxmlformats.org/officeDocument/2006/relationships/slideLayout" Target="../slideLayouts/slideLayout1.xml"/><Relationship Id="rId11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22.jpeg"/><Relationship Id="rId2" Type="http://schemas.openxmlformats.org/officeDocument/2006/relationships/image" Target="../media/image23.jpeg"/><Relationship Id="rId3" Type="http://schemas.openxmlformats.org/officeDocument/2006/relationships/image" Target="../media/image24.jpeg"/><Relationship Id="rId4" Type="http://schemas.openxmlformats.org/officeDocument/2006/relationships/image" Target="../media/image25.jpe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8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5"/>
          <p:cNvSpPr/>
          <p:nvPr/>
        </p:nvSpPr>
        <p:spPr>
          <a:xfrm>
            <a:off x="1440" y="6924240"/>
            <a:ext cx="6262920" cy="12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8480" rIns="78480" tIns="39240" bIns="39240" anchor="ctr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igure S1. Conditions of the prepared bacterial frozen stocks and infectious ratios of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B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) The frozen stocks of MAB S and R type were presented by microscopic image using acid fast staining method.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) BMDMs were infected with both types expressing RFP for 2h, and washed with PBS, and then intracellular bacteria were examined by confocal microscope with mitotracker and cyclophilin D antibody (green). 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49" name="Picture 2" descr=""/>
          <p:cNvPicPr/>
          <p:nvPr/>
        </p:nvPicPr>
        <p:blipFill>
          <a:blip r:embed="rId1"/>
          <a:stretch/>
        </p:blipFill>
        <p:spPr>
          <a:xfrm>
            <a:off x="252360" y="309600"/>
            <a:ext cx="5759640" cy="6497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Rectangle 5"/>
          <p:cNvSpPr/>
          <p:nvPr/>
        </p:nvSpPr>
        <p:spPr>
          <a:xfrm>
            <a:off x="230040" y="6027120"/>
            <a:ext cx="5796000" cy="190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8480" rIns="78480" tIns="39240" bIns="39240" anchor="ctr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igure S2. Apoptotic responses of macrophages infected with MAB, and Heat killed MAB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) Apoptotic cell death of MAB S- or R type-infected BMDM. The BMDMs were infected with both types      of MAB (MOI = 5) for 2 h, treated by kanamycin (34 </a:t>
            </a:r>
            <a:r>
              <a:rPr b="0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/ml) for additional 2 h, and washed three times with PBS, refreshed with the culture medium containing 10% FBS and 1 % antibiotics and 34 </a:t>
            </a:r>
            <a:r>
              <a:rPr b="0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/ml of kanamycin. After 48 h, the infected BMDMs were washed with PBS and stained with annexin-V/PI staining kit. (b) Apoptosis of RAW264.7 cells infected with live MAB R and S types, heat-killed MAB R (HK-R) and S (HK-S) (MOI = 5) for 4 h was measured by flow cytometry using annexin-V/PI staining. 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1" name="TextBox 3"/>
          <p:cNvSpPr/>
          <p:nvPr/>
        </p:nvSpPr>
        <p:spPr>
          <a:xfrm>
            <a:off x="902160" y="30960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52" name="Picture 2" descr=""/>
          <p:cNvPicPr/>
          <p:nvPr/>
        </p:nvPicPr>
        <p:blipFill>
          <a:blip r:embed="rId1"/>
          <a:stretch/>
        </p:blipFill>
        <p:spPr>
          <a:xfrm>
            <a:off x="1044720" y="598320"/>
            <a:ext cx="4181400" cy="172404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3" descr=""/>
          <p:cNvPicPr/>
          <p:nvPr/>
        </p:nvPicPr>
        <p:blipFill>
          <a:blip r:embed="rId2"/>
          <a:stretch/>
        </p:blipFill>
        <p:spPr>
          <a:xfrm>
            <a:off x="1025640" y="2685960"/>
            <a:ext cx="4209840" cy="3314880"/>
          </a:xfrm>
          <a:prstGeom prst="rect">
            <a:avLst/>
          </a:prstGeom>
          <a:ln w="0">
            <a:noFill/>
          </a:ln>
        </p:spPr>
      </p:pic>
      <p:sp>
        <p:nvSpPr>
          <p:cNvPr id="54" name="TextBox 6"/>
          <p:cNvSpPr/>
          <p:nvPr/>
        </p:nvSpPr>
        <p:spPr>
          <a:xfrm>
            <a:off x="896040" y="261468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Rectangle 5"/>
          <p:cNvSpPr/>
          <p:nvPr/>
        </p:nvSpPr>
        <p:spPr>
          <a:xfrm>
            <a:off x="0" y="3417120"/>
            <a:ext cx="6264360" cy="9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8480" rIns="78480" tIns="39240" bIns="39240" anchor="ctr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igure S3. Cyto-toxicity of MAB and its culture filtrate antigens (CFA)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ell survival of RAW264.7 cells was measured by using trypan blue staining at 24 h after infection with MAB R or S type (MOI = 5) (left panel) and treatment with the R type CFA (R-CFA) or S type CFA (S-CFA) at 10 μg/ml (right panel). The data are the mean ± SEM from two experiments (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n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= 3 per group), ***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&lt; 0.001.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56" name="Picture 3" descr=""/>
          <p:cNvPicPr/>
          <p:nvPr/>
        </p:nvPicPr>
        <p:blipFill>
          <a:blip r:embed="rId1"/>
          <a:stretch/>
        </p:blipFill>
        <p:spPr>
          <a:xfrm>
            <a:off x="1332000" y="1030320"/>
            <a:ext cx="3504960" cy="2085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2" descr=""/>
          <p:cNvPicPr/>
          <p:nvPr/>
        </p:nvPicPr>
        <p:blipFill>
          <a:blip r:embed="rId1"/>
          <a:stretch/>
        </p:blipFill>
        <p:spPr>
          <a:xfrm>
            <a:off x="2138400" y="965160"/>
            <a:ext cx="996840" cy="99864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3" descr=""/>
          <p:cNvPicPr/>
          <p:nvPr/>
        </p:nvPicPr>
        <p:blipFill>
          <a:blip r:embed="rId2"/>
          <a:stretch/>
        </p:blipFill>
        <p:spPr>
          <a:xfrm>
            <a:off x="3174840" y="965160"/>
            <a:ext cx="1001880" cy="998640"/>
          </a:xfrm>
          <a:prstGeom prst="rect">
            <a:avLst/>
          </a:prstGeom>
          <a:ln w="0">
            <a:noFill/>
          </a:ln>
        </p:spPr>
      </p:pic>
      <p:grpSp>
        <p:nvGrpSpPr>
          <p:cNvPr id="59" name="그룹 8"/>
          <p:cNvGrpSpPr/>
          <p:nvPr/>
        </p:nvGrpSpPr>
        <p:grpSpPr>
          <a:xfrm>
            <a:off x="2030040" y="3898080"/>
            <a:ext cx="213120" cy="213840"/>
            <a:chOff x="2030040" y="3898080"/>
            <a:chExt cx="213120" cy="213840"/>
          </a:xfrm>
        </p:grpSpPr>
        <p:cxnSp>
          <p:nvCxnSpPr>
            <p:cNvPr id="60" name="직선 화살표 연결선 26"/>
            <p:cNvCxnSpPr/>
            <p:nvPr/>
          </p:nvCxnSpPr>
          <p:spPr>
            <a:xfrm flipV="1">
              <a:off x="2030040" y="3898080"/>
              <a:ext cx="1080" cy="2134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lg" type="arrow" w="med"/>
            </a:ln>
          </p:spPr>
        </p:cxnSp>
        <p:cxnSp>
          <p:nvCxnSpPr>
            <p:cNvPr id="61" name="직선 화살표 연결선 27"/>
            <p:cNvCxnSpPr/>
            <p:nvPr/>
          </p:nvCxnSpPr>
          <p:spPr>
            <a:xfrm>
              <a:off x="2030040" y="4111200"/>
              <a:ext cx="21348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lg" type="arrow" w="med"/>
            </a:ln>
          </p:spPr>
        </p:cxnSp>
      </p:grpSp>
      <p:sp>
        <p:nvSpPr>
          <p:cNvPr id="62" name="TextBox 6"/>
          <p:cNvSpPr/>
          <p:nvPr/>
        </p:nvSpPr>
        <p:spPr>
          <a:xfrm>
            <a:off x="2220480" y="3997440"/>
            <a:ext cx="192816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2000" rIns="72000" tIns="36000" bIns="36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1D, CHCl</a:t>
            </a:r>
            <a:r>
              <a:rPr b="0" lang="en-US" sz="9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:MeOH:H</a:t>
            </a:r>
            <a:r>
              <a:rPr b="0" lang="en-US" sz="9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O=65:25:4, v/v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3" name="TextBox 7"/>
          <p:cNvSpPr/>
          <p:nvPr/>
        </p:nvSpPr>
        <p:spPr>
          <a:xfrm rot="16200000">
            <a:off x="724320" y="2352600"/>
            <a:ext cx="263088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2000" rIns="72000" tIns="36000" bIns="36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2D, CHCl</a:t>
            </a:r>
            <a:r>
              <a:rPr b="0" lang="en-US" sz="9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:MeOH:CH</a:t>
            </a:r>
            <a:r>
              <a:rPr b="0" lang="en-US" sz="9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3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COOH:H</a:t>
            </a:r>
            <a:r>
              <a:rPr b="0" lang="en-US" sz="9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O=40:6:7.5:2, v/v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4" name="TextBox 8"/>
          <p:cNvSpPr/>
          <p:nvPr/>
        </p:nvSpPr>
        <p:spPr>
          <a:xfrm>
            <a:off x="2136600" y="974880"/>
            <a:ext cx="45252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2000" rIns="72000" tIns="36000" bIns="36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5" name="TextBox 9"/>
          <p:cNvSpPr/>
          <p:nvPr/>
        </p:nvSpPr>
        <p:spPr>
          <a:xfrm>
            <a:off x="3159000" y="973080"/>
            <a:ext cx="45252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2000" rIns="72000" tIns="36000" bIns="36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R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6" name="TextBox 10"/>
          <p:cNvSpPr/>
          <p:nvPr/>
        </p:nvSpPr>
        <p:spPr>
          <a:xfrm>
            <a:off x="2480400" y="1201680"/>
            <a:ext cx="29700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2000" rIns="72000" tIns="36000" bIns="36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Arial"/>
                <a:ea typeface="Arial"/>
              </a:rPr>
              <a:t>PE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7" name="TextBox 11"/>
          <p:cNvSpPr/>
          <p:nvPr/>
        </p:nvSpPr>
        <p:spPr>
          <a:xfrm>
            <a:off x="2870640" y="1181160"/>
            <a:ext cx="29088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2000" rIns="72000" tIns="36000" bIns="36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Arial"/>
                <a:ea typeface="Arial"/>
              </a:rPr>
              <a:t>CL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8" name="TextBox 12"/>
          <p:cNvSpPr/>
          <p:nvPr/>
        </p:nvSpPr>
        <p:spPr>
          <a:xfrm>
            <a:off x="2488680" y="1677960"/>
            <a:ext cx="40536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2000" rIns="72000" tIns="36000" bIns="36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Arial"/>
                <a:ea typeface="Arial"/>
              </a:rPr>
              <a:t>PIMs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69" name="Picture 2" descr=""/>
          <p:cNvPicPr/>
          <p:nvPr/>
        </p:nvPicPr>
        <p:blipFill>
          <a:blip r:embed="rId3"/>
          <a:stretch/>
        </p:blipFill>
        <p:spPr>
          <a:xfrm>
            <a:off x="2127240" y="1990800"/>
            <a:ext cx="998640" cy="99864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3" descr=""/>
          <p:cNvPicPr/>
          <p:nvPr/>
        </p:nvPicPr>
        <p:blipFill>
          <a:blip r:embed="rId4"/>
          <a:stretch/>
        </p:blipFill>
        <p:spPr>
          <a:xfrm>
            <a:off x="3178080" y="1990800"/>
            <a:ext cx="998640" cy="998640"/>
          </a:xfrm>
          <a:prstGeom prst="rect">
            <a:avLst/>
          </a:prstGeom>
          <a:ln w="0">
            <a:noFill/>
          </a:ln>
        </p:spPr>
      </p:pic>
      <p:sp>
        <p:nvSpPr>
          <p:cNvPr id="71" name="TextBox 15"/>
          <p:cNvSpPr/>
          <p:nvPr/>
        </p:nvSpPr>
        <p:spPr>
          <a:xfrm>
            <a:off x="2136600" y="2008080"/>
            <a:ext cx="45252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2000" rIns="72000" tIns="36000" bIns="36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2" name="TextBox 17"/>
          <p:cNvSpPr/>
          <p:nvPr/>
        </p:nvSpPr>
        <p:spPr>
          <a:xfrm>
            <a:off x="3159000" y="2006640"/>
            <a:ext cx="45252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2000" rIns="72000" tIns="36000" bIns="36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R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3" name="TextBox 18"/>
          <p:cNvSpPr/>
          <p:nvPr/>
        </p:nvSpPr>
        <p:spPr>
          <a:xfrm>
            <a:off x="2738160" y="2313000"/>
            <a:ext cx="29700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2000" rIns="72000" tIns="36000" bIns="36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Arial"/>
                <a:ea typeface="Arial"/>
              </a:rPr>
              <a:t>PE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4" name="TextBox 19"/>
          <p:cNvSpPr/>
          <p:nvPr/>
        </p:nvSpPr>
        <p:spPr>
          <a:xfrm>
            <a:off x="2865240" y="2138400"/>
            <a:ext cx="29088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2000" rIns="72000" tIns="36000" bIns="36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Arial"/>
                <a:ea typeface="Arial"/>
              </a:rPr>
              <a:t>CL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5" name="TextBox 20"/>
          <p:cNvSpPr/>
          <p:nvPr/>
        </p:nvSpPr>
        <p:spPr>
          <a:xfrm>
            <a:off x="2495160" y="2682720"/>
            <a:ext cx="40536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2000" rIns="72000" tIns="36000" bIns="36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Arial"/>
                <a:ea typeface="Arial"/>
              </a:rPr>
              <a:t>PIMs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76" name="Picture 2" descr=""/>
          <p:cNvPicPr/>
          <p:nvPr/>
        </p:nvPicPr>
        <p:blipFill>
          <a:blip r:embed="rId5"/>
          <a:stretch/>
        </p:blipFill>
        <p:spPr>
          <a:xfrm>
            <a:off x="2127240" y="3009960"/>
            <a:ext cx="998640" cy="99864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3" descr=""/>
          <p:cNvPicPr/>
          <p:nvPr/>
        </p:nvPicPr>
        <p:blipFill>
          <a:blip r:embed="rId6"/>
          <a:stretch/>
        </p:blipFill>
        <p:spPr>
          <a:xfrm>
            <a:off x="3166920" y="3009960"/>
            <a:ext cx="997200" cy="998640"/>
          </a:xfrm>
          <a:prstGeom prst="rect">
            <a:avLst/>
          </a:prstGeom>
          <a:ln w="0">
            <a:noFill/>
          </a:ln>
        </p:spPr>
      </p:pic>
      <p:sp>
        <p:nvSpPr>
          <p:cNvPr id="78" name="TextBox 23"/>
          <p:cNvSpPr/>
          <p:nvPr/>
        </p:nvSpPr>
        <p:spPr>
          <a:xfrm>
            <a:off x="2136600" y="3016080"/>
            <a:ext cx="45252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2000" rIns="72000" tIns="36000" bIns="36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9" name="TextBox 24"/>
          <p:cNvSpPr/>
          <p:nvPr/>
        </p:nvSpPr>
        <p:spPr>
          <a:xfrm>
            <a:off x="3159000" y="3013200"/>
            <a:ext cx="45252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2000" rIns="72000" tIns="36000" bIns="36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R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0" name="TextBox 25"/>
          <p:cNvSpPr/>
          <p:nvPr/>
        </p:nvSpPr>
        <p:spPr>
          <a:xfrm>
            <a:off x="2720160" y="3336840"/>
            <a:ext cx="29700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2000" rIns="72000" tIns="36000" bIns="36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Arial"/>
                <a:ea typeface="Arial"/>
              </a:rPr>
              <a:t>PE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1" name="직사각형 47"/>
          <p:cNvSpPr/>
          <p:nvPr/>
        </p:nvSpPr>
        <p:spPr>
          <a:xfrm>
            <a:off x="0" y="4710240"/>
            <a:ext cx="6264360" cy="1023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8480" rIns="78480" tIns="39240" bIns="3924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719280"/>
                <a:tab algn="l" pos="1438200"/>
                <a:tab algn="l" pos="2157480"/>
                <a:tab algn="l" pos="2876400"/>
                <a:tab algn="l" pos="3595680"/>
                <a:tab algn="l" pos="4314960"/>
                <a:tab algn="l" pos="5033880"/>
                <a:tab algn="l" pos="5753160"/>
                <a:tab algn="l" pos="6472080"/>
                <a:tab algn="l" pos="7191360"/>
                <a:tab algn="l" pos="7910640"/>
                <a:tab algn="l" pos="8629560"/>
                <a:tab algn="l" pos="9348840"/>
                <a:tab algn="l" pos="10067760"/>
                <a:tab algn="l" pos="1078704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igure S4. Comparison of cell wall lipids between MAB R and S types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The major cell wall lipids such as phosphatidylinositol mannosides (PIMs), cardiolipins (CL), and phosphatidylethanolamine (PE) of both morphotypes were separated by two dimensional TLC, and visualized by 20% H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4,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dittmer reagent and ninhydrin reagent.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순서도: 처리 45"/>
          <p:cNvSpPr/>
          <p:nvPr/>
        </p:nvSpPr>
        <p:spPr>
          <a:xfrm>
            <a:off x="1187280" y="453960"/>
            <a:ext cx="720720" cy="360360"/>
          </a:xfrm>
          <a:prstGeom prst="flowChartProcess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36000" rIns="36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  <a:ea typeface="Arial"/>
              </a:rPr>
              <a:t>Sonication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3" name="순서도: 처리 46"/>
          <p:cNvSpPr/>
          <p:nvPr/>
        </p:nvSpPr>
        <p:spPr>
          <a:xfrm>
            <a:off x="2052720" y="1101600"/>
            <a:ext cx="718920" cy="360360"/>
          </a:xfrm>
          <a:prstGeom prst="flowChartProcess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36000" rIns="36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  <a:ea typeface="Arial"/>
              </a:rPr>
              <a:t>Acidification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4" name="순서도: 데이터 47"/>
          <p:cNvSpPr/>
          <p:nvPr/>
        </p:nvSpPr>
        <p:spPr>
          <a:xfrm>
            <a:off x="395280" y="453960"/>
            <a:ext cx="720720" cy="360360"/>
          </a:xfrm>
          <a:prstGeom prst="flowChartInputOutpu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36000" rIns="36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  <a:ea typeface="Arial"/>
              </a:rPr>
              <a:t>Dried MAB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5" name="순서도: 판단 48"/>
          <p:cNvSpPr/>
          <p:nvPr/>
        </p:nvSpPr>
        <p:spPr>
          <a:xfrm>
            <a:off x="2052720" y="453960"/>
            <a:ext cx="718920" cy="360360"/>
          </a:xfrm>
          <a:prstGeom prst="flowChartDecision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36000" rIns="36000" tIns="46800" bIns="46800" anchor="ctr">
            <a:noAutofit/>
          </a:bodyPr>
          <a:p>
            <a:pPr algn="ctr"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맑은 고딕"/>
              </a:rPr>
              <a:t>Spin down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6" name="순서도: 처리 51"/>
          <p:cNvSpPr/>
          <p:nvPr/>
        </p:nvSpPr>
        <p:spPr>
          <a:xfrm>
            <a:off x="3489480" y="453960"/>
            <a:ext cx="720720" cy="360360"/>
          </a:xfrm>
          <a:prstGeom prst="flowChartProcess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36000" rIns="36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  <a:ea typeface="Arial"/>
              </a:rPr>
              <a:t>Acetone precipitation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7" name="순서도: 판단 52"/>
          <p:cNvSpPr/>
          <p:nvPr/>
        </p:nvSpPr>
        <p:spPr>
          <a:xfrm>
            <a:off x="4400640" y="453960"/>
            <a:ext cx="720720" cy="360360"/>
          </a:xfrm>
          <a:prstGeom prst="flowChartDecision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36000" rIns="36000" tIns="46800" bIns="46800" anchor="ctr">
            <a:noAutofit/>
          </a:bodyPr>
          <a:p>
            <a:pPr algn="ctr"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맑은 고딕"/>
              </a:rPr>
              <a:t>Spin down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8" name="순서도: 데이터 53"/>
          <p:cNvSpPr/>
          <p:nvPr/>
        </p:nvSpPr>
        <p:spPr>
          <a:xfrm>
            <a:off x="2052720" y="1606680"/>
            <a:ext cx="718920" cy="360360"/>
          </a:xfrm>
          <a:prstGeom prst="flowChartInputOutpu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18000" rIns="18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  <a:ea typeface="Arial"/>
              </a:rPr>
              <a:t>Mycolic acid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9" name="순서도: 데이터 55"/>
          <p:cNvSpPr/>
          <p:nvPr/>
        </p:nvSpPr>
        <p:spPr>
          <a:xfrm>
            <a:off x="2700360" y="1606680"/>
            <a:ext cx="719280" cy="360360"/>
          </a:xfrm>
          <a:prstGeom prst="flowChartInputOutpu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36000" rIns="36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  <a:ea typeface="Arial"/>
              </a:rPr>
              <a:t>Total lipid extract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0" name="순서도: 데이터 56"/>
          <p:cNvSpPr/>
          <p:nvPr/>
        </p:nvSpPr>
        <p:spPr>
          <a:xfrm>
            <a:off x="4400640" y="1606680"/>
            <a:ext cx="720720" cy="360360"/>
          </a:xfrm>
          <a:prstGeom prst="flowChartInputOutpu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36000" rIns="36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  <a:ea typeface="Arial"/>
              </a:rPr>
              <a:t>GPLs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1" name="순서도: 데이터 57"/>
          <p:cNvSpPr/>
          <p:nvPr/>
        </p:nvSpPr>
        <p:spPr>
          <a:xfrm>
            <a:off x="5076720" y="1606680"/>
            <a:ext cx="719280" cy="360360"/>
          </a:xfrm>
          <a:prstGeom prst="flowChartInputOutpu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36000" rIns="36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  <a:ea typeface="Arial"/>
              </a:rPr>
              <a:t>APP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cxnSp>
        <p:nvCxnSpPr>
          <p:cNvPr id="92" name="직선 화살표 연결선 59"/>
          <p:cNvCxnSpPr>
            <a:stCxn id="84" idx="5"/>
            <a:endCxn id="82" idx="1"/>
          </p:cNvCxnSpPr>
          <p:nvPr/>
        </p:nvCxnSpPr>
        <p:spPr>
          <a:xfrm>
            <a:off x="1044720" y="632880"/>
            <a:ext cx="14328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3" name="직선 화살표 연결선 61"/>
          <p:cNvCxnSpPr>
            <a:stCxn id="82" idx="3"/>
            <a:endCxn id="85" idx="1"/>
          </p:cNvCxnSpPr>
          <p:nvPr/>
        </p:nvCxnSpPr>
        <p:spPr>
          <a:xfrm>
            <a:off x="1908000" y="632880"/>
            <a:ext cx="14544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4" name="직선 화살표 연결선 67"/>
          <p:cNvCxnSpPr>
            <a:stCxn id="86" idx="3"/>
            <a:endCxn id="87" idx="1"/>
          </p:cNvCxnSpPr>
          <p:nvPr/>
        </p:nvCxnSpPr>
        <p:spPr>
          <a:xfrm>
            <a:off x="4209840" y="632880"/>
            <a:ext cx="19116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5" name="직선 화살표 연결선 69"/>
          <p:cNvCxnSpPr>
            <a:stCxn id="87" idx="2"/>
            <a:endCxn id="90" idx="1"/>
          </p:cNvCxnSpPr>
          <p:nvPr/>
        </p:nvCxnSpPr>
        <p:spPr>
          <a:xfrm>
            <a:off x="4760640" y="813960"/>
            <a:ext cx="1080" cy="793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6" name="Shape 73"/>
          <p:cNvCxnSpPr>
            <a:stCxn id="87" idx="3"/>
            <a:endCxn id="91" idx="1"/>
          </p:cNvCxnSpPr>
          <p:nvPr/>
        </p:nvCxnSpPr>
        <p:spPr>
          <a:xfrm>
            <a:off x="5121000" y="633240"/>
            <a:ext cx="316440" cy="974160"/>
          </a:xfrm>
          <a:prstGeom prst="bentConnector2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7" name="직선 화살표 연결선 75"/>
          <p:cNvCxnSpPr>
            <a:stCxn id="85" idx="2"/>
            <a:endCxn id="83" idx="0"/>
          </p:cNvCxnSpPr>
          <p:nvPr/>
        </p:nvCxnSpPr>
        <p:spPr>
          <a:xfrm>
            <a:off x="2410920" y="814320"/>
            <a:ext cx="1080" cy="2880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8" name="직선 화살표 연결선 77"/>
          <p:cNvCxnSpPr>
            <a:stCxn id="83" idx="2"/>
            <a:endCxn id="88" idx="1"/>
          </p:cNvCxnSpPr>
          <p:nvPr/>
        </p:nvCxnSpPr>
        <p:spPr>
          <a:xfrm>
            <a:off x="2410920" y="1461960"/>
            <a:ext cx="1080" cy="1454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99" name="TextBox 78"/>
          <p:cNvSpPr/>
          <p:nvPr/>
        </p:nvSpPr>
        <p:spPr>
          <a:xfrm>
            <a:off x="2505600" y="365040"/>
            <a:ext cx="819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800" spc="-1" strike="noStrike">
                <a:solidFill>
                  <a:srgbClr val="ff0000"/>
                </a:solidFill>
                <a:latin typeface="맑은 고딕"/>
              </a:rPr>
              <a:t>Supernatant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0" name="TextBox 79"/>
          <p:cNvSpPr/>
          <p:nvPr/>
        </p:nvSpPr>
        <p:spPr>
          <a:xfrm>
            <a:off x="2378880" y="806400"/>
            <a:ext cx="471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맑은 고딕"/>
              </a:rPr>
              <a:t>Pellet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1" name="TextBox 80"/>
          <p:cNvSpPr/>
          <p:nvPr/>
        </p:nvSpPr>
        <p:spPr>
          <a:xfrm>
            <a:off x="3991680" y="995400"/>
            <a:ext cx="819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800" spc="-1" strike="noStrike">
                <a:solidFill>
                  <a:srgbClr val="ff0000"/>
                </a:solidFill>
                <a:latin typeface="맑은 고딕"/>
              </a:rPr>
              <a:t>Supernatant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2" name="TextBox 81"/>
          <p:cNvSpPr/>
          <p:nvPr/>
        </p:nvSpPr>
        <p:spPr>
          <a:xfrm>
            <a:off x="5380920" y="995400"/>
            <a:ext cx="471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맑은 고딕"/>
              </a:rPr>
              <a:t>Pellet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cxnSp>
        <p:nvCxnSpPr>
          <p:cNvPr id="103" name="꺾인 연결선 87"/>
          <p:cNvCxnSpPr>
            <a:stCxn id="85" idx="3"/>
            <a:endCxn id="89" idx="1"/>
          </p:cNvCxnSpPr>
          <p:nvPr/>
        </p:nvCxnSpPr>
        <p:spPr>
          <a:xfrm>
            <a:off x="2771280" y="633240"/>
            <a:ext cx="289440" cy="974160"/>
          </a:xfrm>
          <a:prstGeom prst="bentConnector2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pic>
        <p:nvPicPr>
          <p:cNvPr id="104" name="Rectangle 1" descr=""/>
          <p:cNvPicPr/>
          <p:nvPr/>
        </p:nvPicPr>
        <p:blipFill>
          <a:blip r:embed="rId1"/>
          <a:stretch/>
        </p:blipFill>
        <p:spPr>
          <a:xfrm>
            <a:off x="146160" y="2243160"/>
            <a:ext cx="5973480" cy="1695600"/>
          </a:xfrm>
          <a:prstGeom prst="rect">
            <a:avLst/>
          </a:prstGeom>
          <a:ln w="0">
            <a:noFill/>
          </a:ln>
        </p:spPr>
      </p:pic>
      <p:sp>
        <p:nvSpPr>
          <p:cNvPr id="105" name="Rectangle 1"/>
          <p:cNvSpPr/>
          <p:nvPr/>
        </p:nvSpPr>
        <p:spPr>
          <a:xfrm>
            <a:off x="144360" y="4694040"/>
            <a:ext cx="5810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8480" rIns="78480" tIns="39240" bIns="39240" anchor="ctr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able S1. Comparison of the cell wall lipids  purified from MAB S and R types 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106" name="Rectangle 1" descr=""/>
          <p:cNvPicPr/>
          <p:nvPr/>
        </p:nvPicPr>
        <p:blipFill>
          <a:blip r:embed="rId2"/>
          <a:stretch/>
        </p:blipFill>
        <p:spPr>
          <a:xfrm>
            <a:off x="92160" y="6419880"/>
            <a:ext cx="6083280" cy="1236600"/>
          </a:xfrm>
          <a:prstGeom prst="rect">
            <a:avLst/>
          </a:prstGeom>
          <a:ln w="0">
            <a:noFill/>
          </a:ln>
        </p:spPr>
      </p:pic>
      <p:cxnSp>
        <p:nvCxnSpPr>
          <p:cNvPr id="107" name="직선 화살표 연결선 89"/>
          <p:cNvCxnSpPr>
            <a:stCxn id="85" idx="3"/>
            <a:endCxn id="86" idx="1"/>
          </p:cNvCxnSpPr>
          <p:nvPr/>
        </p:nvCxnSpPr>
        <p:spPr>
          <a:xfrm>
            <a:off x="2771640" y="632880"/>
            <a:ext cx="71856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graphicFrame>
        <p:nvGraphicFramePr>
          <p:cNvPr id="108" name=""/>
          <p:cNvGraphicFramePr/>
          <p:nvPr/>
        </p:nvGraphicFramePr>
        <p:xfrm>
          <a:off x="108000" y="5133960"/>
          <a:ext cx="6048360" cy="1224000"/>
        </p:xfrm>
        <a:graphic>
          <a:graphicData uri="http://schemas.openxmlformats.org/drawingml/2006/table">
            <a:tbl>
              <a:tblPr/>
              <a:tblGrid>
                <a:gridCol w="431640"/>
                <a:gridCol w="1270080"/>
                <a:gridCol w="1035000"/>
                <a:gridCol w="1847880"/>
                <a:gridCol w="743040"/>
                <a:gridCol w="720720"/>
              </a:tblGrid>
              <a:tr h="30636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맑은 고딕"/>
                        </a:rPr>
                        <a:t>Separation fro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맑은 고딕"/>
                        </a:rPr>
                        <a:t>20 mg of the pellet after sonication</a:t>
                      </a:r>
                      <a:r>
                        <a:rPr b="0" lang="en-US" sz="800" spc="-1" strike="noStrike" baseline="30000">
                          <a:solidFill>
                            <a:srgbClr val="ff0000"/>
                          </a:solidFill>
                          <a:latin typeface="맑은 고딕"/>
                        </a:rPr>
                        <a:t>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맑은 고딕"/>
                        </a:rPr>
                        <a:t>Separation fro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r>
                        <a:rPr b="0" lang="en-US" sz="800" spc="-1" strike="noStrike">
                          <a:solidFill>
                            <a:srgbClr val="ff0000"/>
                          </a:solidFill>
                          <a:latin typeface="맑은 고딕"/>
                        </a:rPr>
                        <a:t>10 mg of total lipid extracts</a:t>
                      </a:r>
                      <a:r>
                        <a:rPr b="0" lang="en-US" sz="800" spc="-1" strike="noStrike" baseline="30000">
                          <a:solidFill>
                            <a:srgbClr val="ff0000"/>
                          </a:solidFill>
                          <a:latin typeface="맑은 고딕"/>
                        </a:rPr>
                        <a:t>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0636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Typ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Dried bacteria weight (g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Total lipid Extract (g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ycolic acid (mg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GPLs (mg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APP (mg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636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Smoot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0.9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0.15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7.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4.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3.8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Roug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0.9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0.1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6.7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.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719280"/>
                          <a:tab algn="l" pos="1438200"/>
                          <a:tab algn="l" pos="2157480"/>
                          <a:tab algn="l" pos="2876400"/>
                          <a:tab algn="l" pos="3595680"/>
                          <a:tab algn="l" pos="4314960"/>
                          <a:tab algn="l" pos="5033880"/>
                          <a:tab algn="l" pos="5753160"/>
                          <a:tab algn="l" pos="6472080"/>
                          <a:tab algn="l" pos="7191360"/>
                          <a:tab algn="l" pos="7910640"/>
                          <a:tab algn="l" pos="8629560"/>
                          <a:tab algn="l" pos="9348840"/>
                          <a:tab algn="l" pos="10067760"/>
                          <a:tab algn="l" pos="10787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6.4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09" name="직선 연결선 2"/>
          <p:cNvSpPr/>
          <p:nvPr/>
        </p:nvSpPr>
        <p:spPr>
          <a:xfrm>
            <a:off x="144360" y="5133960"/>
            <a:ext cx="5970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0" name="Picture 12" descr=""/>
          <p:cNvPicPr/>
          <p:nvPr/>
        </p:nvPicPr>
        <p:blipFill>
          <a:blip r:embed="rId1"/>
          <a:stretch/>
        </p:blipFill>
        <p:spPr>
          <a:xfrm>
            <a:off x="50760" y="22320"/>
            <a:ext cx="1236600" cy="3241440"/>
          </a:xfrm>
          <a:prstGeom prst="rect">
            <a:avLst/>
          </a:prstGeom>
          <a:ln w="0">
            <a:noFill/>
          </a:ln>
        </p:spPr>
      </p:pic>
      <p:sp>
        <p:nvSpPr>
          <p:cNvPr id="111" name="Rectangle 1"/>
          <p:cNvSpPr/>
          <p:nvPr/>
        </p:nvSpPr>
        <p:spPr>
          <a:xfrm>
            <a:off x="385920" y="6287400"/>
            <a:ext cx="5746680" cy="9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8480" rIns="78480" tIns="39240" bIns="39240" anchor="ctr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igure S6. The structure of some GPL and APP spots on TLC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Among the separated spots on TLC plate shown in Figure 2a, seven spots from GPL and APP fractions were analyzed by MALDITOF MS/MS spectra, and then their structures were schematized. The structures of the spots 6 and 7 appeared in GPL region of APP fraction were not identified.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grpSp>
        <p:nvGrpSpPr>
          <p:cNvPr id="112" name="그룹 23"/>
          <p:cNvGrpSpPr/>
          <p:nvPr/>
        </p:nvGrpSpPr>
        <p:grpSpPr>
          <a:xfrm>
            <a:off x="1332000" y="4341960"/>
            <a:ext cx="4827600" cy="1382400"/>
            <a:chOff x="1332000" y="4341960"/>
            <a:chExt cx="4827600" cy="1382400"/>
          </a:xfrm>
        </p:grpSpPr>
        <p:pic>
          <p:nvPicPr>
            <p:cNvPr id="113" name="Picture 4" descr="C:\Users\Jake Whang\Desktop\S type GPL inhibit Apoptosis\GPL Paper\Ver of CDD\GPL18p.jpg"/>
            <p:cNvPicPr/>
            <p:nvPr/>
          </p:nvPicPr>
          <p:blipFill>
            <a:blip r:embed="rId2"/>
            <a:stretch/>
          </p:blipFill>
          <p:spPr>
            <a:xfrm>
              <a:off x="3954240" y="4341960"/>
              <a:ext cx="2205360" cy="1382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4" name="Picture 5" descr="C:\Users\Jake Whang\Desktop\S type GPL inhibit Apoptosis\GPL Paper\Ver of CDD\GPL18.jpg"/>
            <p:cNvPicPr/>
            <p:nvPr/>
          </p:nvPicPr>
          <p:blipFill>
            <a:blip r:embed="rId3"/>
            <a:stretch/>
          </p:blipFill>
          <p:spPr>
            <a:xfrm>
              <a:off x="1332000" y="4341960"/>
              <a:ext cx="2694240" cy="13622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15" name="그룹 22"/>
          <p:cNvGrpSpPr/>
          <p:nvPr/>
        </p:nvGrpSpPr>
        <p:grpSpPr>
          <a:xfrm>
            <a:off x="1359000" y="3003480"/>
            <a:ext cx="4800600" cy="1382760"/>
            <a:chOff x="1359000" y="3003480"/>
            <a:chExt cx="4800600" cy="1382760"/>
          </a:xfrm>
        </p:grpSpPr>
        <p:pic>
          <p:nvPicPr>
            <p:cNvPr id="116" name="Picture 6" descr="C:\Users\Jake Whang\Desktop\S type GPL inhibit Apoptosis\GPL Paper\Ver of CDD\GPL20p.jpg"/>
            <p:cNvPicPr/>
            <p:nvPr/>
          </p:nvPicPr>
          <p:blipFill>
            <a:blip r:embed="rId4"/>
            <a:stretch/>
          </p:blipFill>
          <p:spPr>
            <a:xfrm>
              <a:off x="3981600" y="3003480"/>
              <a:ext cx="2178000" cy="1382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7" name="Picture 7" descr="C:\Users\Jake Whang\Desktop\S type GPL inhibit Apoptosis\GPL Paper\Ver of CDD\GPL20.jpg"/>
            <p:cNvPicPr/>
            <p:nvPr/>
          </p:nvPicPr>
          <p:blipFill>
            <a:blip r:embed="rId5"/>
            <a:stretch/>
          </p:blipFill>
          <p:spPr>
            <a:xfrm>
              <a:off x="1359000" y="3003480"/>
              <a:ext cx="2694600" cy="109368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18" name="그룹 21"/>
          <p:cNvGrpSpPr/>
          <p:nvPr/>
        </p:nvGrpSpPr>
        <p:grpSpPr>
          <a:xfrm>
            <a:off x="1359000" y="1533600"/>
            <a:ext cx="4800600" cy="1454040"/>
            <a:chOff x="1359000" y="1533600"/>
            <a:chExt cx="4800600" cy="1454040"/>
          </a:xfrm>
        </p:grpSpPr>
        <p:pic>
          <p:nvPicPr>
            <p:cNvPr id="119" name="Picture 8" descr="C:\Users\Jake Whang\Desktop\S type GPL inhibit Apoptosis\GPL Paper\Ver of CDD\GPL21p.jpg"/>
            <p:cNvPicPr/>
            <p:nvPr/>
          </p:nvPicPr>
          <p:blipFill>
            <a:blip r:embed="rId6"/>
            <a:stretch/>
          </p:blipFill>
          <p:spPr>
            <a:xfrm>
              <a:off x="3981600" y="1533600"/>
              <a:ext cx="2178000" cy="1454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0" name="Picture 9" descr="C:\Users\Jake Whang\Desktop\S type GPL inhibit Apoptosis\GPL Paper\Ver of CDD\GPL21.jpg"/>
            <p:cNvPicPr/>
            <p:nvPr/>
          </p:nvPicPr>
          <p:blipFill>
            <a:blip r:embed="rId7"/>
            <a:stretch/>
          </p:blipFill>
          <p:spPr>
            <a:xfrm>
              <a:off x="1359000" y="1533600"/>
              <a:ext cx="2694600" cy="109332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21" name="그룹 20"/>
          <p:cNvGrpSpPr/>
          <p:nvPr/>
        </p:nvGrpSpPr>
        <p:grpSpPr>
          <a:xfrm>
            <a:off x="1359000" y="152280"/>
            <a:ext cx="4800600" cy="1381320"/>
            <a:chOff x="1359000" y="152280"/>
            <a:chExt cx="4800600" cy="1381320"/>
          </a:xfrm>
        </p:grpSpPr>
        <p:pic>
          <p:nvPicPr>
            <p:cNvPr id="122" name="Picture 10" descr="C:\Users\Jake Whang\Desktop\S type GPL inhibit Apoptosis\GPL Paper\Ver of CDD\GPL22p.jpg"/>
            <p:cNvPicPr/>
            <p:nvPr/>
          </p:nvPicPr>
          <p:blipFill>
            <a:blip r:embed="rId8"/>
            <a:stretch/>
          </p:blipFill>
          <p:spPr>
            <a:xfrm>
              <a:off x="3981600" y="152280"/>
              <a:ext cx="2178000" cy="1381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3" name="Picture 11" descr="C:\Users\Jake Whang\Desktop\S type GPL inhibit Apoptosis\GPL Paper\Ver of CDD\GPL22.jpg"/>
            <p:cNvPicPr/>
            <p:nvPr/>
          </p:nvPicPr>
          <p:blipFill>
            <a:blip r:embed="rId9"/>
            <a:stretch/>
          </p:blipFill>
          <p:spPr>
            <a:xfrm>
              <a:off x="1359000" y="152280"/>
              <a:ext cx="2694600" cy="10922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24" name="TextBox 15"/>
          <p:cNvSpPr/>
          <p:nvPr/>
        </p:nvSpPr>
        <p:spPr>
          <a:xfrm>
            <a:off x="578160" y="20383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  <a:ea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5" name="TextBox 16"/>
          <p:cNvSpPr/>
          <p:nvPr/>
        </p:nvSpPr>
        <p:spPr>
          <a:xfrm>
            <a:off x="578160" y="190800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  <a:ea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6" name="TextBox 17"/>
          <p:cNvSpPr/>
          <p:nvPr/>
        </p:nvSpPr>
        <p:spPr>
          <a:xfrm>
            <a:off x="578160" y="15159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  <a:ea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7" name="TextBox 18"/>
          <p:cNvSpPr/>
          <p:nvPr/>
        </p:nvSpPr>
        <p:spPr>
          <a:xfrm>
            <a:off x="578160" y="13906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  <a:ea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8" name="TextBox 19"/>
          <p:cNvSpPr/>
          <p:nvPr/>
        </p:nvSpPr>
        <p:spPr>
          <a:xfrm>
            <a:off x="578160" y="125100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  <a:ea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9" name="TextBox 25"/>
          <p:cNvSpPr/>
          <p:nvPr/>
        </p:nvSpPr>
        <p:spPr>
          <a:xfrm>
            <a:off x="1189800" y="14436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1100" spc="-1" strike="noStrike">
                <a:solidFill>
                  <a:srgbClr val="ff0000"/>
                </a:solidFill>
                <a:latin typeface="Arial"/>
                <a:ea typeface="Arial"/>
              </a:rPr>
              <a:t>1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30" name="TextBox 26"/>
          <p:cNvSpPr/>
          <p:nvPr/>
        </p:nvSpPr>
        <p:spPr>
          <a:xfrm>
            <a:off x="1189800" y="153360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1100" spc="-1" strike="noStrike">
                <a:solidFill>
                  <a:srgbClr val="ff0000"/>
                </a:solidFill>
                <a:latin typeface="Arial"/>
                <a:ea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31" name="TextBox 27"/>
          <p:cNvSpPr/>
          <p:nvPr/>
        </p:nvSpPr>
        <p:spPr>
          <a:xfrm>
            <a:off x="1189800" y="300204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1100" spc="-1" strike="noStrike">
                <a:solidFill>
                  <a:srgbClr val="ff0000"/>
                </a:solidFill>
                <a:latin typeface="Arial"/>
                <a:ea typeface="Arial"/>
              </a:rPr>
              <a:t>3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32" name="TextBox 28"/>
          <p:cNvSpPr/>
          <p:nvPr/>
        </p:nvSpPr>
        <p:spPr>
          <a:xfrm>
            <a:off x="1189800" y="438300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1100" spc="-1" strike="noStrike">
                <a:solidFill>
                  <a:srgbClr val="ff0000"/>
                </a:solidFill>
                <a:latin typeface="Arial"/>
                <a:ea typeface="Arial"/>
              </a:rPr>
              <a:t>4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33" name="TextBox 30"/>
          <p:cNvSpPr/>
          <p:nvPr/>
        </p:nvSpPr>
        <p:spPr>
          <a:xfrm>
            <a:off x="884520" y="186840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  <a:ea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34" name="TextBox 31"/>
          <p:cNvSpPr/>
          <p:nvPr/>
        </p:nvSpPr>
        <p:spPr>
          <a:xfrm>
            <a:off x="884520" y="202104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  <a:ea typeface="Arial"/>
              </a:rPr>
              <a:t>7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TextBox 25"/>
          <p:cNvSpPr/>
          <p:nvPr/>
        </p:nvSpPr>
        <p:spPr>
          <a:xfrm>
            <a:off x="1119240" y="217188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1100" spc="-1" strike="noStrike">
                <a:solidFill>
                  <a:srgbClr val="ff0000"/>
                </a:solidFill>
                <a:latin typeface="Arial"/>
                <a:ea typeface="Arial"/>
              </a:rPr>
              <a:t>6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36" name="TextBox 26"/>
          <p:cNvSpPr/>
          <p:nvPr/>
        </p:nvSpPr>
        <p:spPr>
          <a:xfrm>
            <a:off x="1119240" y="375912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1100" spc="-1" strike="noStrike">
                <a:solidFill>
                  <a:srgbClr val="ff0000"/>
                </a:solidFill>
                <a:latin typeface="Arial"/>
                <a:ea typeface="Arial"/>
              </a:rPr>
              <a:t>7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137" name="Picture 2" descr="C:\Users\Jake Whang\Desktop\S type GPL inhibit Apoptosis\GPL Paper\Ver of CDD\APP25.jpg"/>
          <p:cNvPicPr/>
          <p:nvPr/>
        </p:nvPicPr>
        <p:blipFill>
          <a:blip r:embed="rId1"/>
          <a:stretch/>
        </p:blipFill>
        <p:spPr>
          <a:xfrm>
            <a:off x="1333440" y="3909960"/>
            <a:ext cx="2319480" cy="1474920"/>
          </a:xfrm>
          <a:prstGeom prst="rect">
            <a:avLst/>
          </a:prstGeom>
          <a:ln w="0">
            <a:noFill/>
          </a:ln>
        </p:spPr>
      </p:pic>
      <p:pic>
        <p:nvPicPr>
          <p:cNvPr id="138" name="Picture 3" descr="C:\Users\Jake Whang\Desktop\S type GPL inhibit Apoptosis\GPL Paper\Ver of CDD\APP26.jpg"/>
          <p:cNvPicPr/>
          <p:nvPr/>
        </p:nvPicPr>
        <p:blipFill>
          <a:blip r:embed="rId2"/>
          <a:stretch/>
        </p:blipFill>
        <p:spPr>
          <a:xfrm>
            <a:off x="1333440" y="2325600"/>
            <a:ext cx="2322720" cy="1474920"/>
          </a:xfrm>
          <a:prstGeom prst="rect">
            <a:avLst/>
          </a:prstGeom>
          <a:ln w="0">
            <a:noFill/>
          </a:ln>
        </p:spPr>
      </p:pic>
      <p:sp>
        <p:nvSpPr>
          <p:cNvPr id="139" name="TextBox 32"/>
          <p:cNvSpPr/>
          <p:nvPr/>
        </p:nvSpPr>
        <p:spPr>
          <a:xfrm>
            <a:off x="2849400" y="2360520"/>
            <a:ext cx="752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Unknown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40" name="TextBox 33"/>
          <p:cNvSpPr/>
          <p:nvPr/>
        </p:nvSpPr>
        <p:spPr>
          <a:xfrm>
            <a:off x="2849400" y="3944880"/>
            <a:ext cx="752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Unknown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grpSp>
        <p:nvGrpSpPr>
          <p:cNvPr id="141" name="그룹 21"/>
          <p:cNvGrpSpPr/>
          <p:nvPr/>
        </p:nvGrpSpPr>
        <p:grpSpPr>
          <a:xfrm>
            <a:off x="1131840" y="531720"/>
            <a:ext cx="4827600" cy="1382760"/>
            <a:chOff x="1131840" y="531720"/>
            <a:chExt cx="4827600" cy="1382760"/>
          </a:xfrm>
        </p:grpSpPr>
        <p:pic>
          <p:nvPicPr>
            <p:cNvPr id="142" name="Picture 2" descr="C:\Users\Jake Whang\Desktop\S type GPL inhibit Apoptosis\GPL Paper\Ver of CDD\GPL17.jpg"/>
            <p:cNvPicPr/>
            <p:nvPr/>
          </p:nvPicPr>
          <p:blipFill>
            <a:blip r:embed="rId3"/>
            <a:stretch/>
          </p:blipFill>
          <p:spPr>
            <a:xfrm>
              <a:off x="1131840" y="531720"/>
              <a:ext cx="2694240" cy="1362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3" name="Picture 3" descr="C:\Users\Jake Whang\Desktop\S type GPL inhibit Apoptosis\GPL Paper\Ver of CDD\GPL17p.jpg"/>
            <p:cNvPicPr/>
            <p:nvPr/>
          </p:nvPicPr>
          <p:blipFill>
            <a:blip r:embed="rId4"/>
            <a:stretch/>
          </p:blipFill>
          <p:spPr>
            <a:xfrm>
              <a:off x="3754080" y="531720"/>
              <a:ext cx="2205360" cy="13827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44" name="TextBox 24"/>
          <p:cNvSpPr/>
          <p:nvPr/>
        </p:nvSpPr>
        <p:spPr>
          <a:xfrm>
            <a:off x="1163520" y="263520"/>
            <a:ext cx="208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1100" spc="-1" strike="noStrike">
                <a:solidFill>
                  <a:srgbClr val="ff0000"/>
                </a:solidFill>
                <a:latin typeface="Arial"/>
                <a:ea typeface="Arial"/>
              </a:rPr>
              <a:t>5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45" name="Rectangle 1"/>
          <p:cNvSpPr/>
          <p:nvPr/>
        </p:nvSpPr>
        <p:spPr>
          <a:xfrm>
            <a:off x="352440" y="5859720"/>
            <a:ext cx="5746680" cy="9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8480" rIns="78480" tIns="39240" bIns="39240" anchor="ctr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igure S6. The structure of some GPL and APP spots on TLC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Among the separated spots on TLC plate shown in Figure 2a, seven spots from GPL and APP fractions were analyzed by MALDITOF MS/MS spectra, and then their structures were schematized. The structures of the spots 6 and 7 appeared in GPL region of APP fraction were not identified.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Rectangle 1"/>
          <p:cNvSpPr/>
          <p:nvPr/>
        </p:nvSpPr>
        <p:spPr>
          <a:xfrm>
            <a:off x="0" y="6759360"/>
            <a:ext cx="6264360" cy="1032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8480" rIns="78480" tIns="39240" bIns="39240" anchor="ctr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igure S7. GPLs inhibit the intrinsic apoptosis pathway in macrophages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AW264.7 cells pretreated with GPLs for 1 h were stimulated with TNF-α (20 ng/ml) and cycloheximide (CHX, 2 μg/ml), oligomycin (5 μg/ml), H</a:t>
            </a:r>
            <a:r>
              <a:rPr b="0" lang="en-US" sz="1000" spc="-1" strike="noStrike" baseline="-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O</a:t>
            </a:r>
            <a:r>
              <a:rPr b="0" lang="en-US" sz="1000" spc="-1" strike="noStrike" baseline="-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(0.5 mM), or staurosporine (STS, 100 nM) for 24 h and the apoptotic responses induced by each stimulant were determined by flow cytometry. Representative results of three experiments are shown.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147" name="Picture 2" descr=""/>
          <p:cNvPicPr/>
          <p:nvPr/>
        </p:nvPicPr>
        <p:blipFill>
          <a:blip r:embed="rId1"/>
          <a:srcRect l="0" t="1579" r="0" b="1053"/>
          <a:stretch/>
        </p:blipFill>
        <p:spPr>
          <a:xfrm>
            <a:off x="1476360" y="22320"/>
            <a:ext cx="3828960" cy="6657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Rectangle 1"/>
          <p:cNvSpPr/>
          <p:nvPr/>
        </p:nvSpPr>
        <p:spPr>
          <a:xfrm>
            <a:off x="0" y="4653720"/>
            <a:ext cx="6264360" cy="190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8480" rIns="78480" tIns="39240" bIns="39240" anchor="ctr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782640"/>
                <a:tab algn="l" pos="1565280"/>
                <a:tab algn="l" pos="2347920"/>
                <a:tab algn="l" pos="3130560"/>
                <a:tab algn="l" pos="3913200"/>
                <a:tab algn="l" pos="4695840"/>
                <a:tab algn="l" pos="5478480"/>
                <a:tab algn="l" pos="6261120"/>
                <a:tab algn="l" pos="7043760"/>
                <a:tab algn="l" pos="7826400"/>
                <a:tab algn="l" pos="8609040"/>
                <a:tab algn="l" pos="9391680"/>
                <a:tab algn="l" pos="10174320"/>
                <a:tab algn="l" pos="1095696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igure S8. Acetylation of GPLs is essential for apoptotic inhibition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Because polarity in MAB GPLs is created by glycosylation of alaninol and acetylation of 6-deoxytalose, deacetylated GPLs were prepared using alkaline lysis. RAW264.7 cells were pretreated with deacetylated R-type GPLs (dGPL-R) (left) or S-type GPLs (dGPL-S) (right) and stimulated with oligomycin (5 μg/ml) for 24 h. The apoptotic responses of RAW264.7 cells were analyzed by FACS with Annexin V/PI staining. The population of apoptotic cells was calculated from the lower and upper right quadrants (Q2, Q4; Annexin V+, PI±). Data shown are the mean ± SEM from three experiments (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n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= 3 per group). *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&lt; 0.05, **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&lt; 0.01, ***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&lt; 0.001 (one-way ANOVA); ns, not significant.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149" name="Picture 2" descr=""/>
          <p:cNvPicPr/>
          <p:nvPr/>
        </p:nvPicPr>
        <p:blipFill>
          <a:blip r:embed="rId1"/>
          <a:stretch/>
        </p:blipFill>
        <p:spPr>
          <a:xfrm>
            <a:off x="1044720" y="1990800"/>
            <a:ext cx="4100400" cy="2423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7-22T04:16:07Z</dcterms:created>
  <dc:creator>Jake Whang</dc:creator>
  <dc:description/>
  <dc:language>en-US</dc:language>
  <cp:lastModifiedBy>ravikumar.n</cp:lastModifiedBy>
  <cp:lastPrinted>2017-07-19T00:36:39Z</cp:lastPrinted>
  <dcterms:modified xsi:type="dcterms:W3CDTF">2017-08-18T11:46:34Z</dcterms:modified>
  <cp:revision>260</cp:revision>
  <dc:subject/>
  <dc:title>슬라이드 1</dc:title>
</cp:coreProperties>
</file>